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AD672F-7CCC-4978-A1F0-3E14EEC50D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60099-8104-42FC-B229-12193127B4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98B96-2480-4052-806F-DD0A4EF0EB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C32DF-F1C1-4DF5-9EAD-BAACD05463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6066F-BA3F-4D92-B540-DB309691D9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B167D-9698-4D5F-91BD-09F3AC2E97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7345BD-39F7-46AE-9E59-5596686CF3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66947-F3B4-408B-AFCB-5764AF32A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E71B0-70B3-4D18-B41C-9238FFCF1E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84669-7F12-4816-8E40-BC9A6D7FC7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8EA073-B8C2-4B8A-8EE6-A6D6D7EFE8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206C5-CD7E-46E5-8544-F818022416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B43CB16-2DAB-42CB-BC34-B41C9AB554D3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Diagramm 29" descr=""/>
          <p:cNvPicPr/>
          <p:nvPr/>
        </p:nvPicPr>
        <p:blipFill>
          <a:blip r:embed="rId1"/>
          <a:stretch/>
        </p:blipFill>
        <p:spPr>
          <a:xfrm>
            <a:off x="237960" y="-6480"/>
            <a:ext cx="6626520" cy="3627720"/>
          </a:xfrm>
          <a:prstGeom prst="rect">
            <a:avLst/>
          </a:prstGeom>
          <a:ln w="0">
            <a:noFill/>
          </a:ln>
        </p:spPr>
      </p:pic>
      <p:pic>
        <p:nvPicPr>
          <p:cNvPr id="42" name="Diagramm 30" descr=""/>
          <p:cNvPicPr/>
          <p:nvPr/>
        </p:nvPicPr>
        <p:blipFill>
          <a:blip r:embed="rId2"/>
          <a:stretch/>
        </p:blipFill>
        <p:spPr>
          <a:xfrm>
            <a:off x="146160" y="3687840"/>
            <a:ext cx="6748200" cy="3700440"/>
          </a:xfrm>
          <a:prstGeom prst="rect">
            <a:avLst/>
          </a:prstGeom>
          <a:ln w="0">
            <a:noFill/>
          </a:ln>
        </p:spPr>
      </p:pic>
      <p:sp>
        <p:nvSpPr>
          <p:cNvPr id="43" name="Textfeld 6"/>
          <p:cNvSpPr/>
          <p:nvPr/>
        </p:nvSpPr>
        <p:spPr>
          <a:xfrm>
            <a:off x="4082040" y="9536040"/>
            <a:ext cx="27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feld 24"/>
          <p:cNvSpPr/>
          <p:nvPr/>
        </p:nvSpPr>
        <p:spPr>
          <a:xfrm>
            <a:off x="11520" y="572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feld 25"/>
          <p:cNvSpPr/>
          <p:nvPr/>
        </p:nvSpPr>
        <p:spPr>
          <a:xfrm>
            <a:off x="11520" y="36259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feld 13"/>
          <p:cNvSpPr/>
          <p:nvPr/>
        </p:nvSpPr>
        <p:spPr>
          <a:xfrm>
            <a:off x="2372040" y="3255840"/>
            <a:ext cx="106632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0.1 ng/ml RANK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feld 14"/>
          <p:cNvSpPr/>
          <p:nvPr/>
        </p:nvSpPr>
        <p:spPr>
          <a:xfrm>
            <a:off x="3975840" y="3255840"/>
            <a:ext cx="9702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 ng/ml RANK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feld 15"/>
          <p:cNvSpPr/>
          <p:nvPr/>
        </p:nvSpPr>
        <p:spPr>
          <a:xfrm>
            <a:off x="5521680" y="3255840"/>
            <a:ext cx="103428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0 ng/ml RANK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feld 16"/>
          <p:cNvSpPr/>
          <p:nvPr/>
        </p:nvSpPr>
        <p:spPr>
          <a:xfrm>
            <a:off x="2372040" y="7015320"/>
            <a:ext cx="106632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0.1 ng/ml RANK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feld 17"/>
          <p:cNvSpPr/>
          <p:nvPr/>
        </p:nvSpPr>
        <p:spPr>
          <a:xfrm>
            <a:off x="3975840" y="7015320"/>
            <a:ext cx="9702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 ng/ml RANK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feld 18"/>
          <p:cNvSpPr/>
          <p:nvPr/>
        </p:nvSpPr>
        <p:spPr>
          <a:xfrm>
            <a:off x="5521680" y="7015320"/>
            <a:ext cx="103428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0 ng/ml RANK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7T09:58:55Z</dcterms:created>
  <dc:creator>Katharina Pardon</dc:creator>
  <dc:description/>
  <dc:language>en-US</dc:language>
  <cp:lastModifiedBy>ravikumar.n</cp:lastModifiedBy>
  <cp:lastPrinted>2013-11-07T20:20:33Z</cp:lastPrinted>
  <dcterms:modified xsi:type="dcterms:W3CDTF">2014-06-05T16:18:15Z</dcterms:modified>
  <cp:revision>98</cp:revision>
  <dc:subject/>
  <dc:title>Folie 1</dc:title>
</cp:coreProperties>
</file>